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Default Extension="wdp" ContentType="image/vnd.ms-photo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2232" y="-16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jpeg"/><Relationship Id="rId26" Type="http://schemas.microsoft.com/office/2007/relationships/hdphoto" Target="../media/hdphoto12.wdp"/><Relationship Id="rId3" Type="http://schemas.microsoft.com/office/2007/relationships/hdphoto" Target="../media/hdphoto1.wdp"/><Relationship Id="rId21" Type="http://schemas.openxmlformats.org/officeDocument/2006/relationships/image" Target="../media/image11.jpeg"/><Relationship Id="rId34" Type="http://schemas.openxmlformats.org/officeDocument/2006/relationships/image" Target="../media/image18.jpeg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openxmlformats.org/officeDocument/2006/relationships/image" Target="../media/image13.jpeg"/><Relationship Id="rId33" Type="http://schemas.microsoft.com/office/2007/relationships/hdphoto" Target="../media/hdphoto15.wdp"/><Relationship Id="rId2" Type="http://schemas.openxmlformats.org/officeDocument/2006/relationships/image" Target="../media/image1.jpeg"/><Relationship Id="rId16" Type="http://schemas.openxmlformats.org/officeDocument/2006/relationships/image" Target="../media/image8.jpeg"/><Relationship Id="rId20" Type="http://schemas.openxmlformats.org/officeDocument/2006/relationships/image" Target="../media/image10.jpeg"/><Relationship Id="rId29" Type="http://schemas.microsoft.com/office/2007/relationships/hdphoto" Target="../media/hdphoto13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microsoft.com/office/2007/relationships/hdphoto" Target="../media/hdphoto11.wdp"/><Relationship Id="rId32" Type="http://schemas.openxmlformats.org/officeDocument/2006/relationships/image" Target="../media/image17.jpe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openxmlformats.org/officeDocument/2006/relationships/image" Target="../media/image12.png"/><Relationship Id="rId28" Type="http://schemas.openxmlformats.org/officeDocument/2006/relationships/image" Target="../media/image15.png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microsoft.com/office/2007/relationships/hdphoto" Target="../media/hdphoto14.wdp"/><Relationship Id="rId4" Type="http://schemas.openxmlformats.org/officeDocument/2006/relationships/image" Target="../media/image2.jpe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microsoft.com/office/2007/relationships/hdphoto" Target="../media/hdphoto10.wdp"/><Relationship Id="rId27" Type="http://schemas.openxmlformats.org/officeDocument/2006/relationships/image" Target="../media/image14.jpeg"/><Relationship Id="rId30" Type="http://schemas.openxmlformats.org/officeDocument/2006/relationships/image" Target="../media/image16.jpeg"/><Relationship Id="rId35" Type="http://schemas.microsoft.com/office/2007/relationships/hdphoto" Target="../media/hdphoto16.wdp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H:\far\8_4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000" contrast="-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3161" y="82394"/>
            <a:ext cx="1606239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3" descr="H:\far\8_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6000" contrast="1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560" y="82394"/>
            <a:ext cx="1588877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4" descr="H:\far\8_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000"/>
                    </a14:imgEffect>
                    <a14:imgEffect>
                      <a14:brightnessContrast bright="29000" contrast="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8763" y="82393"/>
            <a:ext cx="1571551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5" descr="H:\far\8_3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1000" contrast="-1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2961" y="82392"/>
            <a:ext cx="1577554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6" descr="H:\far\10_4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17000" contras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3160" y="1468451"/>
            <a:ext cx="1606239" cy="13649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7" descr="H:\far\10_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12000" contrast="2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560" y="1468451"/>
            <a:ext cx="1588877" cy="13649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8" descr="H:\far\10_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17000" contras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8763" y="1468451"/>
            <a:ext cx="1571551" cy="13649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9" descr="H:\far\10_3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4000" contras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3160" y="4232195"/>
            <a:ext cx="1606239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10" descr="H:\far\octo 4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4000" contrast="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560" y="2840159"/>
            <a:ext cx="1588878" cy="13714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11" descr="H:\far\Capture_00041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8763" y="2840052"/>
            <a:ext cx="1571551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2" descr="H:\far\Capture_00002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2000" contrast="1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3160" y="5638907"/>
            <a:ext cx="1606239" cy="13133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13" descr="H:\far\Capture_00012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6000" contras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3468" y="1468581"/>
            <a:ext cx="1567046" cy="13648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14" descr="H:\far\Capture_00005_2.JPG"/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23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094" t="36600" r="12510"/>
          <a:stretch/>
        </p:blipFill>
        <p:spPr bwMode="auto">
          <a:xfrm>
            <a:off x="5023160" y="2840052"/>
            <a:ext cx="1606239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15" descr="H:\far\Capture_00046.JPG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2959" y="4232195"/>
            <a:ext cx="1577555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2" descr="H:\octo  94x 72 hr.JPG"/>
          <p:cNvPicPr>
            <a:picLocks noChangeAspect="1" noChangeArrowheads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25000" contrast="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1828762" y="4232195"/>
            <a:ext cx="157155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3" descr="H:\Capture_00012.JPG"/>
          <p:cNvPicPr>
            <a:picLocks noChangeAspect="1" noChangeArrowheads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3161" y="6954851"/>
            <a:ext cx="160160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4" descr="C:\Users\Victor\Desktop\water 1 72 hr.JPG"/>
          <p:cNvPicPr>
            <a:picLocks noChangeAspect="1" noChangeArrowheads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1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559020" y="5513354"/>
            <a:ext cx="1315943" cy="15670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8" descr="H:\far\Capture_00007.JPG"/>
          <p:cNvPicPr>
            <a:picLocks noChangeAspect="1" noChangeArrowheads="1"/>
          </p:cNvPicPr>
          <p:nvPr/>
        </p:nvPicPr>
        <p:blipFill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3468" y="2840052"/>
            <a:ext cx="1567046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0" name="TextBox 29"/>
          <p:cNvSpPr txBox="1"/>
          <p:nvPr/>
        </p:nvSpPr>
        <p:spPr>
          <a:xfrm>
            <a:off x="249337" y="82980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Arial Black" pitchFamily="34" charset="0"/>
              </a:rPr>
              <a:t>A</a:t>
            </a:r>
            <a:endParaRPr lang="en-US" sz="1200" dirty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822758" y="76200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Arial Black" pitchFamily="34" charset="0"/>
              </a:rPr>
              <a:t>B</a:t>
            </a:r>
            <a:endParaRPr lang="en-US" sz="1200" dirty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433468" y="76200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Arial Black" pitchFamily="34" charset="0"/>
              </a:rPr>
              <a:t>C</a:t>
            </a:r>
            <a:endParaRPr lang="en-US" sz="1200" dirty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004105" y="82980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Arial Black" pitchFamily="34" charset="0"/>
              </a:rPr>
              <a:t>D</a:t>
            </a:r>
            <a:endParaRPr lang="en-US" sz="1200" dirty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938962" y="1176992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smtClean="0">
                <a:solidFill>
                  <a:schemeClr val="bg1"/>
                </a:solidFill>
                <a:latin typeface="Arial Black" pitchFamily="34" charset="0"/>
              </a:rPr>
              <a:t>8 h</a:t>
            </a:r>
            <a:endParaRPr lang="en-US" sz="1200" dirty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943600" y="2556399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smtClean="0">
                <a:solidFill>
                  <a:schemeClr val="bg1"/>
                </a:solidFill>
                <a:latin typeface="Arial Black" pitchFamily="34" charset="0"/>
              </a:rPr>
              <a:t>10 h</a:t>
            </a:r>
            <a:endParaRPr lang="en-US" sz="1200" dirty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932275" y="3932753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smtClean="0">
                <a:solidFill>
                  <a:schemeClr val="bg1"/>
                </a:solidFill>
                <a:latin typeface="Arial Black" pitchFamily="34" charset="0"/>
              </a:rPr>
              <a:t>12 h</a:t>
            </a:r>
            <a:endParaRPr lang="en-US" sz="1200" dirty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943600" y="8049452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smtClean="0">
                <a:solidFill>
                  <a:schemeClr val="bg1"/>
                </a:solidFill>
                <a:latin typeface="Arial Black" pitchFamily="34" charset="0"/>
              </a:rPr>
              <a:t>18 h</a:t>
            </a:r>
            <a:endParaRPr lang="en-US" sz="1200" dirty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943600" y="5314958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smtClean="0">
                <a:solidFill>
                  <a:schemeClr val="bg1"/>
                </a:solidFill>
                <a:latin typeface="Arial Black" pitchFamily="34" charset="0"/>
              </a:rPr>
              <a:t>14 h</a:t>
            </a:r>
            <a:endParaRPr lang="en-US" sz="1200" dirty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926237" y="6675290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smtClean="0">
                <a:solidFill>
                  <a:schemeClr val="bg1"/>
                </a:solidFill>
                <a:latin typeface="Arial Black" pitchFamily="34" charset="0"/>
              </a:rPr>
              <a:t>16 h</a:t>
            </a:r>
            <a:endParaRPr lang="en-US" sz="1200" dirty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0" y="8389203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Comparative invasion of </a:t>
            </a:r>
            <a:r>
              <a:rPr lang="en-US" sz="1200" b="1" i="1" dirty="0" err="1"/>
              <a:t>Meloidogyne</a:t>
            </a:r>
            <a:r>
              <a:rPr lang="en-US" sz="1200" b="1" dirty="0"/>
              <a:t> </a:t>
            </a:r>
            <a:r>
              <a:rPr lang="en-US" sz="1200" b="1" i="1" dirty="0"/>
              <a:t>incognita</a:t>
            </a:r>
            <a:r>
              <a:rPr lang="en-US" sz="1200" b="1" dirty="0"/>
              <a:t> in host root. </a:t>
            </a:r>
            <a:r>
              <a:rPr lang="en-US" sz="1200" dirty="0"/>
              <a:t>(A) – untreated J2, (B) – Endospore</a:t>
            </a:r>
            <a:r>
              <a:rPr lang="en-US" sz="1200" i="1" dirty="0"/>
              <a:t> </a:t>
            </a:r>
            <a:r>
              <a:rPr lang="en-US" sz="1200" dirty="0"/>
              <a:t>encumbered J2, (C) – </a:t>
            </a:r>
            <a:r>
              <a:rPr lang="en-US" sz="1200" dirty="0" err="1"/>
              <a:t>dsRNA</a:t>
            </a:r>
            <a:r>
              <a:rPr lang="en-US" sz="1200" dirty="0"/>
              <a:t> treated J2, (D) – Endospore encumbered </a:t>
            </a:r>
            <a:r>
              <a:rPr lang="en-US" sz="1200" dirty="0" err="1"/>
              <a:t>dsRNA</a:t>
            </a:r>
            <a:r>
              <a:rPr lang="en-US" sz="1200" dirty="0"/>
              <a:t> treated J2. Maximum J2s observed invaded the root tip in A, B, C and D were at 12, 14, 16 and 18 h post inoculation. </a:t>
            </a:r>
          </a:p>
          <a:p>
            <a:pPr algn="just"/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6852561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357628" y="7706380"/>
            <a:ext cx="52578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err="1">
                <a:latin typeface="Times New Roman" pitchFamily="18" charset="0"/>
                <a:cs typeface="Times New Roman" pitchFamily="18" charset="0"/>
              </a:rPr>
              <a:t>Moens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et al. (2009) </a:t>
            </a:r>
            <a:r>
              <a:rPr lang="en-US" sz="1400" i="1" dirty="0" err="1">
                <a:latin typeface="Times New Roman" pitchFamily="18" charset="0"/>
                <a:cs typeface="Times New Roman" pitchFamily="18" charset="0"/>
              </a:rPr>
              <a:t>Meloidogyne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Species – a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Diverse Group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of Novel and Important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Plant Parasites. In (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eds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) Root knot nematodes (by) Perry RM,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Moens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M and Starr JL (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oi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10.1079/9781845934927.0001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485900" y="457200"/>
            <a:ext cx="3886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Life cycle of </a:t>
            </a:r>
            <a:r>
              <a:rPr lang="en-US" b="1" i="1" dirty="0" err="1" smtClean="0">
                <a:latin typeface="Times New Roman" pitchFamily="18" charset="0"/>
                <a:cs typeface="Times New Roman" pitchFamily="18" charset="0"/>
              </a:rPr>
              <a:t>Meloidogyne</a:t>
            </a:r>
            <a:r>
              <a:rPr lang="en-US" b="1" i="1" dirty="0" smtClean="0">
                <a:latin typeface="Times New Roman" pitchFamily="18" charset="0"/>
                <a:cs typeface="Times New Roman" pitchFamily="18" charset="0"/>
              </a:rPr>
              <a:t> incognita</a:t>
            </a:r>
            <a:endParaRPr 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26505" y="6400800"/>
            <a:ext cx="640498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“Diagram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of the life cycle of the root-knot nematode, </a:t>
            </a:r>
            <a:r>
              <a:rPr lang="en-US" sz="1600" i="1" dirty="0" err="1">
                <a:latin typeface="Times New Roman" pitchFamily="18" charset="0"/>
                <a:cs typeface="Times New Roman" pitchFamily="18" charset="0"/>
              </a:rPr>
              <a:t>Meloidogyne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. J2: second-stage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juvenile; J3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: third-stage juvenile; J4: fourth-stage juvenile. (Adapted from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Karssen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Moens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2006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)”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0" y="-144463"/>
            <a:ext cx="6549694" cy="6321128"/>
            <a:chOff x="155575" y="-144463"/>
            <a:chExt cx="6549694" cy="6321128"/>
          </a:xfrm>
        </p:grpSpPr>
        <p:sp>
          <p:nvSpPr>
            <p:cNvPr id="2" name="AutoShape 2" descr="Related image"/>
            <p:cNvSpPr>
              <a:spLocks noChangeAspect="1" noChangeArrowheads="1"/>
            </p:cNvSpPr>
            <p:nvPr/>
          </p:nvSpPr>
          <p:spPr bwMode="auto">
            <a:xfrm>
              <a:off x="155575" y="-144463"/>
              <a:ext cx="304800" cy="3048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1027" name="Picture 3" descr="C:\Users\Victor\Desktop\Fig-11-Diagram-of-the-life-cycle-of-the-root-knot-nematode-Meloidogyne-J2.ppm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27403" y="1566565"/>
              <a:ext cx="5340855" cy="4191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5715000" y="2895600"/>
              <a:ext cx="87897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Adult female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791200" y="4295001"/>
              <a:ext cx="8789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Egg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334000" y="5634335"/>
              <a:ext cx="13712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First </a:t>
              </a:r>
              <a:r>
                <a:rPr lang="en-US" sz="1200" b="1" dirty="0" err="1" smtClean="0">
                  <a:latin typeface="Times New Roman" pitchFamily="18" charset="0"/>
                  <a:cs typeface="Times New Roman" pitchFamily="18" charset="0"/>
                </a:rPr>
                <a:t>moult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 (egg with juvenile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667000" y="5715000"/>
              <a:ext cx="158360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Infective juvenile (pre-parasitic J2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94097" y="5658134"/>
              <a:ext cx="158360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J2 after feeding (parasitic J2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49735" y="4255826"/>
              <a:ext cx="9783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J3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04937" y="2895600"/>
              <a:ext cx="9783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J4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754482" y="1981200"/>
              <a:ext cx="87897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Adult male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15841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1.PPTX</DocumentId>
    <TitleName xmlns="fa52ae8b-2b36-4137-9bde-d98e18ca3240">Presentation 1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9DFE6F5A-CEC3-4CFA-8FA8-89086E1CB0B7}"/>
</file>

<file path=customXml/itemProps2.xml><?xml version="1.0" encoding="utf-8"?>
<ds:datastoreItem xmlns:ds="http://schemas.openxmlformats.org/officeDocument/2006/customXml" ds:itemID="{6DBD1E42-533E-42DC-9DDA-2AB4894690C3}"/>
</file>

<file path=customXml/itemProps3.xml><?xml version="1.0" encoding="utf-8"?>
<ds:datastoreItem xmlns:ds="http://schemas.openxmlformats.org/officeDocument/2006/customXml" ds:itemID="{D8A796F0-76AE-4DA8-8494-2D596CCC43C0}"/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98</Words>
  <Application>Microsoft Office PowerPoint</Application>
  <PresentationFormat>On-screen Show (4:3)</PresentationFormat>
  <Paragraphs>2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CTOR P</dc:creator>
  <cp:lastModifiedBy>ismail - [2010]</cp:lastModifiedBy>
  <cp:revision>8</cp:revision>
  <dcterms:created xsi:type="dcterms:W3CDTF">2006-08-16T00:00:00Z</dcterms:created>
  <dcterms:modified xsi:type="dcterms:W3CDTF">2017-10-15T05:25:22Z</dcterms:modified>
</cp:coreProperties>
</file>